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07200" cy="9906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398" y="-2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NI CD16'!$K$152</c:f>
              <c:strCache>
                <c:ptCount val="1"/>
                <c:pt idx="0">
                  <c:v>BASA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ANI CD16'!$O$153:$O$154</c:f>
                <c:numCache>
                  <c:formatCode>General</c:formatCode>
                  <c:ptCount val="2"/>
                  <c:pt idx="0">
                    <c:v>3.905124837953327</c:v>
                  </c:pt>
                  <c:pt idx="1">
                    <c:v>2.676371230409369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'SANI CD16'!$J$153:$J$154</c:f>
              <c:strCache>
                <c:ptCount val="2"/>
                <c:pt idx="0">
                  <c:v>V/V</c:v>
                </c:pt>
                <c:pt idx="1">
                  <c:v>F carrier</c:v>
                </c:pt>
              </c:strCache>
            </c:strRef>
          </c:cat>
          <c:val>
            <c:numRef>
              <c:f>'SANI CD16'!$K$153:$K$154</c:f>
              <c:numCache>
                <c:formatCode>0.00</c:formatCode>
                <c:ptCount val="2"/>
                <c:pt idx="0">
                  <c:v>2</c:v>
                </c:pt>
                <c:pt idx="1">
                  <c:v>1.8</c:v>
                </c:pt>
              </c:numCache>
            </c:numRef>
          </c:val>
        </c:ser>
        <c:ser>
          <c:idx val="1"/>
          <c:order val="1"/>
          <c:tx>
            <c:strRef>
              <c:f>'SANI CD16'!$L$152</c:f>
              <c:strCache>
                <c:ptCount val="1"/>
                <c:pt idx="0">
                  <c:v>ADCC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ANI CD16'!$P$153:$P$154</c:f>
                <c:numCache>
                  <c:formatCode>General</c:formatCode>
                  <c:ptCount val="2"/>
                  <c:pt idx="0">
                    <c:v>18.317417333723053</c:v>
                  </c:pt>
                  <c:pt idx="1">
                    <c:v>15.5514135899751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'SANI CD16'!$J$153:$J$154</c:f>
              <c:strCache>
                <c:ptCount val="2"/>
                <c:pt idx="0">
                  <c:v>V/V</c:v>
                </c:pt>
                <c:pt idx="1">
                  <c:v>F carrier</c:v>
                </c:pt>
              </c:strCache>
            </c:strRef>
          </c:cat>
          <c:val>
            <c:numRef>
              <c:f>'SANI CD16'!$L$153:$L$154</c:f>
              <c:numCache>
                <c:formatCode>0.00</c:formatCode>
                <c:ptCount val="2"/>
                <c:pt idx="0">
                  <c:v>11.555555555555555</c:v>
                </c:pt>
                <c:pt idx="1">
                  <c:v>15.4727272727272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437504"/>
        <c:axId val="78819712"/>
      </c:barChart>
      <c:catAx>
        <c:axId val="7043750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78819712"/>
        <c:crosses val="autoZero"/>
        <c:auto val="1"/>
        <c:lblAlgn val="ctr"/>
        <c:lblOffset val="100"/>
        <c:noMultiLvlLbl val="0"/>
      </c:catAx>
      <c:valAx>
        <c:axId val="78819712"/>
        <c:scaling>
          <c:orientation val="minMax"/>
          <c:max val="40"/>
          <c:min val="0"/>
        </c:scaling>
        <c:delete val="0"/>
        <c:axPos val="l"/>
        <c:numFmt formatCode="0;[Red]0" sourceLinked="0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70437504"/>
        <c:crosses val="autoZero"/>
        <c:crossBetween val="between"/>
        <c:majorUnit val="10"/>
      </c:valAx>
    </c:plotArea>
    <c:legend>
      <c:legendPos val="r"/>
      <c:layout>
        <c:manualLayout>
          <c:xMode val="edge"/>
          <c:yMode val="edge"/>
          <c:x val="0.34626610006847947"/>
          <c:y val="6.2714431350078509E-2"/>
          <c:w val="0.24236178774610043"/>
          <c:h val="0.20600544449360036"/>
        </c:manualLayout>
      </c:layout>
      <c:overlay val="0"/>
      <c:txPr>
        <a:bodyPr/>
        <a:lstStyle/>
        <a:p>
          <a:pPr>
            <a:defRPr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NI CD32'!$K$155</c:f>
              <c:strCache>
                <c:ptCount val="1"/>
                <c:pt idx="0">
                  <c:v>BASA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ANI CD32'!$K$156:$K$157</c:f>
                <c:numCache>
                  <c:formatCode>General</c:formatCode>
                  <c:ptCount val="2"/>
                  <c:pt idx="0">
                    <c:v>1.2857142857142858</c:v>
                  </c:pt>
                  <c:pt idx="1">
                    <c:v>2.093023255813953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'SANI CD32'!$J$156:$J$157</c:f>
              <c:strCache>
                <c:ptCount val="2"/>
                <c:pt idx="0">
                  <c:v>H/H</c:v>
                </c:pt>
                <c:pt idx="1">
                  <c:v>R carrier</c:v>
                </c:pt>
              </c:strCache>
            </c:strRef>
          </c:cat>
          <c:val>
            <c:numRef>
              <c:f>'SANI CD32'!$K$156:$K$157</c:f>
              <c:numCache>
                <c:formatCode>0.00</c:formatCode>
                <c:ptCount val="2"/>
                <c:pt idx="0">
                  <c:v>1.2857142857142858</c:v>
                </c:pt>
                <c:pt idx="1">
                  <c:v>2.0930232558139537</c:v>
                </c:pt>
              </c:numCache>
            </c:numRef>
          </c:val>
        </c:ser>
        <c:ser>
          <c:idx val="1"/>
          <c:order val="1"/>
          <c:tx>
            <c:strRef>
              <c:f>'SANI CD32'!$L$155</c:f>
              <c:strCache>
                <c:ptCount val="1"/>
                <c:pt idx="0">
                  <c:v>ADCC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ANI CD32'!$L$156:$L$157</c:f>
                <c:numCache>
                  <c:formatCode>General</c:formatCode>
                  <c:ptCount val="2"/>
                  <c:pt idx="0">
                    <c:v>11.523809523809524</c:v>
                  </c:pt>
                  <c:pt idx="1">
                    <c:v>16.5813953488372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'SANI CD32'!$J$156:$J$157</c:f>
              <c:strCache>
                <c:ptCount val="2"/>
                <c:pt idx="0">
                  <c:v>H/H</c:v>
                </c:pt>
                <c:pt idx="1">
                  <c:v>R carrier</c:v>
                </c:pt>
              </c:strCache>
            </c:strRef>
          </c:cat>
          <c:val>
            <c:numRef>
              <c:f>'SANI CD32'!$L$156:$L$157</c:f>
              <c:numCache>
                <c:formatCode>0.00</c:formatCode>
                <c:ptCount val="2"/>
                <c:pt idx="0">
                  <c:v>11.523809523809524</c:v>
                </c:pt>
                <c:pt idx="1">
                  <c:v>16.5813953488372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8890496"/>
        <c:axId val="78892032"/>
      </c:barChart>
      <c:catAx>
        <c:axId val="7889049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78892032"/>
        <c:crosses val="autoZero"/>
        <c:auto val="1"/>
        <c:lblAlgn val="ctr"/>
        <c:lblOffset val="100"/>
        <c:noMultiLvlLbl val="0"/>
      </c:catAx>
      <c:valAx>
        <c:axId val="78892032"/>
        <c:scaling>
          <c:orientation val="minMax"/>
          <c:max val="4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78890496"/>
        <c:crosses val="autoZero"/>
        <c:crossBetween val="between"/>
        <c:majorUnit val="10"/>
      </c:valAx>
    </c:plotArea>
    <c:legend>
      <c:legendPos val="r"/>
      <c:layout>
        <c:manualLayout>
          <c:xMode val="edge"/>
          <c:yMode val="edge"/>
          <c:x val="0.37704045739946207"/>
          <c:y val="3.6396604938271605E-2"/>
          <c:w val="0.16487027430066284"/>
          <c:h val="0.22165123456790123"/>
        </c:manualLayout>
      </c:layout>
      <c:overlay val="0"/>
      <c:txPr>
        <a:bodyPr/>
        <a:lstStyle/>
        <a:p>
          <a:pPr>
            <a:defRPr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NI CD16'!$K$152</c:f>
              <c:strCache>
                <c:ptCount val="1"/>
                <c:pt idx="0">
                  <c:v>BASA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ANI CD16'!$O$153:$O$154</c:f>
                <c:numCache>
                  <c:formatCode>General</c:formatCode>
                  <c:ptCount val="2"/>
                  <c:pt idx="0">
                    <c:v>1.6666666666666667</c:v>
                  </c:pt>
                  <c:pt idx="1">
                    <c:v>1.46059348668044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'SANI CD16'!$J$153:$J$154</c:f>
              <c:strCache>
                <c:ptCount val="2"/>
                <c:pt idx="0">
                  <c:v>V/V</c:v>
                </c:pt>
                <c:pt idx="1">
                  <c:v>F carrier</c:v>
                </c:pt>
              </c:strCache>
            </c:strRef>
          </c:cat>
          <c:val>
            <c:numRef>
              <c:f>'SANI CD16'!$K$153:$K$154</c:f>
              <c:numCache>
                <c:formatCode>0.00</c:formatCode>
                <c:ptCount val="2"/>
                <c:pt idx="0">
                  <c:v>0.55555555555555558</c:v>
                </c:pt>
                <c:pt idx="1">
                  <c:v>0.6</c:v>
                </c:pt>
              </c:numCache>
            </c:numRef>
          </c:val>
        </c:ser>
        <c:ser>
          <c:idx val="1"/>
          <c:order val="1"/>
          <c:tx>
            <c:strRef>
              <c:f>'SANI CD16'!$L$152</c:f>
              <c:strCache>
                <c:ptCount val="1"/>
                <c:pt idx="0">
                  <c:v>ADCC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ANI CD16'!$P$153:$P$154</c:f>
                <c:numCache>
                  <c:formatCode>General</c:formatCode>
                  <c:ptCount val="2"/>
                  <c:pt idx="0">
                    <c:v>13.610657588816199</c:v>
                  </c:pt>
                  <c:pt idx="1">
                    <c:v>10.22497766991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'SANI CD16'!$J$153:$J$154</c:f>
              <c:strCache>
                <c:ptCount val="2"/>
                <c:pt idx="0">
                  <c:v>V/V</c:v>
                </c:pt>
                <c:pt idx="1">
                  <c:v>F carrier</c:v>
                </c:pt>
              </c:strCache>
            </c:strRef>
          </c:cat>
          <c:val>
            <c:numRef>
              <c:f>'SANI CD16'!$L$153:$L$154</c:f>
              <c:numCache>
                <c:formatCode>0.00</c:formatCode>
                <c:ptCount val="2"/>
                <c:pt idx="0">
                  <c:v>9.6666666666666661</c:v>
                </c:pt>
                <c:pt idx="1">
                  <c:v>10.4727272727272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8942592"/>
        <c:axId val="78944128"/>
      </c:barChart>
      <c:catAx>
        <c:axId val="7894259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78944128"/>
        <c:crosses val="autoZero"/>
        <c:auto val="1"/>
        <c:lblAlgn val="ctr"/>
        <c:lblOffset val="100"/>
        <c:noMultiLvlLbl val="0"/>
      </c:catAx>
      <c:valAx>
        <c:axId val="78944128"/>
        <c:scaling>
          <c:orientation val="minMax"/>
          <c:max val="25"/>
          <c:min val="0"/>
        </c:scaling>
        <c:delete val="0"/>
        <c:axPos val="l"/>
        <c:numFmt formatCode="0;[Red]0" sourceLinked="0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78942592"/>
        <c:crosses val="autoZero"/>
        <c:crossBetween val="between"/>
        <c:majorUnit val="5"/>
      </c:valAx>
    </c:plotArea>
    <c:legend>
      <c:legendPos val="r"/>
      <c:layout>
        <c:manualLayout>
          <c:xMode val="edge"/>
          <c:yMode val="edge"/>
          <c:x val="0.39336703100086906"/>
          <c:y val="7.656946577498111E-2"/>
          <c:w val="0.1765229706363064"/>
          <c:h val="0.19276831386219317"/>
        </c:manualLayout>
      </c:layout>
      <c:overlay val="0"/>
      <c:txPr>
        <a:bodyPr/>
        <a:lstStyle/>
        <a:p>
          <a:pPr>
            <a:defRPr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NI CD32'!$K$155</c:f>
              <c:strCache>
                <c:ptCount val="1"/>
                <c:pt idx="0">
                  <c:v>BASA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ANI CD32'!$K$156:$K$157</c:f>
                <c:numCache>
                  <c:formatCode>General</c:formatCode>
                  <c:ptCount val="2"/>
                  <c:pt idx="0">
                    <c:v>0.7142857142857143</c:v>
                  </c:pt>
                  <c:pt idx="1">
                    <c:v>0.534883720930232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'SANI CD32'!$J$156:$J$157</c:f>
              <c:strCache>
                <c:ptCount val="2"/>
                <c:pt idx="0">
                  <c:v>H/H</c:v>
                </c:pt>
                <c:pt idx="1">
                  <c:v>R carrier</c:v>
                </c:pt>
              </c:strCache>
            </c:strRef>
          </c:cat>
          <c:val>
            <c:numRef>
              <c:f>'SANI CD32'!$K$156:$K$157</c:f>
              <c:numCache>
                <c:formatCode>0.00</c:formatCode>
                <c:ptCount val="2"/>
                <c:pt idx="0">
                  <c:v>0.7142857142857143</c:v>
                </c:pt>
                <c:pt idx="1">
                  <c:v>0.53488372093023251</c:v>
                </c:pt>
              </c:numCache>
            </c:numRef>
          </c:val>
        </c:ser>
        <c:ser>
          <c:idx val="1"/>
          <c:order val="1"/>
          <c:tx>
            <c:strRef>
              <c:f>'SANI CD32'!$L$155</c:f>
              <c:strCache>
                <c:ptCount val="1"/>
                <c:pt idx="0">
                  <c:v>ADCC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ANI CD32'!$L$156:$L$157</c:f>
                <c:numCache>
                  <c:formatCode>General</c:formatCode>
                  <c:ptCount val="2"/>
                  <c:pt idx="0">
                    <c:v>7.7619047619047619</c:v>
                  </c:pt>
                  <c:pt idx="1">
                    <c:v>11.6279069767441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'SANI CD32'!$J$156:$J$157</c:f>
              <c:strCache>
                <c:ptCount val="2"/>
                <c:pt idx="0">
                  <c:v>H/H</c:v>
                </c:pt>
                <c:pt idx="1">
                  <c:v>R carrier</c:v>
                </c:pt>
              </c:strCache>
            </c:strRef>
          </c:cat>
          <c:val>
            <c:numRef>
              <c:f>'SANI CD32'!$L$156:$L$157</c:f>
              <c:numCache>
                <c:formatCode>0.00</c:formatCode>
                <c:ptCount val="2"/>
                <c:pt idx="0">
                  <c:v>7.7619047619047619</c:v>
                </c:pt>
                <c:pt idx="1">
                  <c:v>11.6279069767441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9019008"/>
        <c:axId val="79024896"/>
      </c:barChart>
      <c:catAx>
        <c:axId val="790190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79024896"/>
        <c:crosses val="autoZero"/>
        <c:auto val="1"/>
        <c:lblAlgn val="ctr"/>
        <c:lblOffset val="100"/>
        <c:noMultiLvlLbl val="0"/>
      </c:catAx>
      <c:valAx>
        <c:axId val="79024896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790190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37669268404139583"/>
          <c:y val="5.8881161460590595E-2"/>
          <c:w val="0.16408161147713146"/>
          <c:h val="0.20197309181622039"/>
        </c:manualLayout>
      </c:layout>
      <c:overlay val="0"/>
      <c:txPr>
        <a:bodyPr/>
        <a:lstStyle/>
        <a:p>
          <a:pPr>
            <a:defRPr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NI CD16'!$K$151</c:f>
              <c:strCache>
                <c:ptCount val="1"/>
                <c:pt idx="0">
                  <c:v>BASA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ANI CD16'!$O$152:$O$153</c:f>
                <c:numCache>
                  <c:formatCode>General</c:formatCode>
                  <c:ptCount val="2"/>
                  <c:pt idx="0">
                    <c:v>2.9767618499152917</c:v>
                  </c:pt>
                  <c:pt idx="1">
                    <c:v>2.97554567329625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'SANI CD16'!$J$152:$J$153</c:f>
              <c:strCache>
                <c:ptCount val="2"/>
                <c:pt idx="0">
                  <c:v>V/V</c:v>
                </c:pt>
                <c:pt idx="1">
                  <c:v>F carrier</c:v>
                </c:pt>
              </c:strCache>
            </c:strRef>
          </c:cat>
          <c:val>
            <c:numRef>
              <c:f>'SANI CD16'!$K$152:$K$153</c:f>
              <c:numCache>
                <c:formatCode>0.00</c:formatCode>
                <c:ptCount val="2"/>
                <c:pt idx="0">
                  <c:v>1.1111111111111112</c:v>
                </c:pt>
                <c:pt idx="1">
                  <c:v>1.3272727272727274</c:v>
                </c:pt>
              </c:numCache>
            </c:numRef>
          </c:val>
        </c:ser>
        <c:ser>
          <c:idx val="1"/>
          <c:order val="1"/>
          <c:tx>
            <c:strRef>
              <c:f>'SANI CD16'!$L$151</c:f>
              <c:strCache>
                <c:ptCount val="1"/>
                <c:pt idx="0">
                  <c:v>ADCC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ANI CD16'!$P$152:$P$153</c:f>
                <c:numCache>
                  <c:formatCode>General</c:formatCode>
                  <c:ptCount val="2"/>
                  <c:pt idx="0">
                    <c:v>17.326120294065966</c:v>
                  </c:pt>
                  <c:pt idx="1">
                    <c:v>14.2902099708192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'SANI CD16'!$J$152:$J$153</c:f>
              <c:strCache>
                <c:ptCount val="2"/>
                <c:pt idx="0">
                  <c:v>V/V</c:v>
                </c:pt>
                <c:pt idx="1">
                  <c:v>F carrier</c:v>
                </c:pt>
              </c:strCache>
            </c:strRef>
          </c:cat>
          <c:val>
            <c:numRef>
              <c:f>'SANI CD16'!$L$152:$L$153</c:f>
              <c:numCache>
                <c:formatCode>0.00</c:formatCode>
                <c:ptCount val="2"/>
                <c:pt idx="0">
                  <c:v>9.7777777777777786</c:v>
                </c:pt>
                <c:pt idx="1">
                  <c:v>9.7090909090909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8755712"/>
        <c:axId val="78757248"/>
      </c:barChart>
      <c:catAx>
        <c:axId val="7875571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78757248"/>
        <c:crosses val="autoZero"/>
        <c:auto val="1"/>
        <c:lblAlgn val="ctr"/>
        <c:lblOffset val="100"/>
        <c:noMultiLvlLbl val="0"/>
      </c:catAx>
      <c:valAx>
        <c:axId val="78757248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78755712"/>
        <c:crosses val="autoZero"/>
        <c:crossBetween val="between"/>
        <c:majorUnit val="5"/>
      </c:valAx>
    </c:plotArea>
    <c:legend>
      <c:legendPos val="r"/>
      <c:layout>
        <c:manualLayout>
          <c:xMode val="edge"/>
          <c:yMode val="edge"/>
          <c:x val="0.39998674151509372"/>
          <c:y val="8.74523575551205E-2"/>
          <c:w val="0.16408161147713146"/>
          <c:h val="0.21882641518057788"/>
        </c:manualLayout>
      </c:layout>
      <c:overlay val="0"/>
      <c:txPr>
        <a:bodyPr/>
        <a:lstStyle/>
        <a:p>
          <a:pPr>
            <a:defRPr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NI CD32'!$K$155</c:f>
              <c:strCache>
                <c:ptCount val="1"/>
                <c:pt idx="0">
                  <c:v>BASA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ANI CD32'!$O$156:$O$157</c:f>
                <c:numCache>
                  <c:formatCode>General</c:formatCode>
                  <c:ptCount val="2"/>
                  <c:pt idx="0">
                    <c:v>2.0528725518857018</c:v>
                  </c:pt>
                  <c:pt idx="1">
                    <c:v>3.28946773910985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'SANI CD32'!$J$156:$J$157</c:f>
              <c:strCache>
                <c:ptCount val="2"/>
                <c:pt idx="0">
                  <c:v>H/H</c:v>
                </c:pt>
                <c:pt idx="1">
                  <c:v>R carrier</c:v>
                </c:pt>
              </c:strCache>
            </c:strRef>
          </c:cat>
          <c:val>
            <c:numRef>
              <c:f>'SANI CD32'!$K$156:$K$157</c:f>
              <c:numCache>
                <c:formatCode>0.00</c:formatCode>
                <c:ptCount val="2"/>
                <c:pt idx="0">
                  <c:v>0.7142857142857143</c:v>
                </c:pt>
                <c:pt idx="1">
                  <c:v>1.5813953488372092</c:v>
                </c:pt>
              </c:numCache>
            </c:numRef>
          </c:val>
        </c:ser>
        <c:ser>
          <c:idx val="1"/>
          <c:order val="1"/>
          <c:tx>
            <c:strRef>
              <c:f>'SANI CD32'!$L$155</c:f>
              <c:strCache>
                <c:ptCount val="1"/>
                <c:pt idx="0">
                  <c:v>ADCC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ANI CD32'!$P$156:$P$157</c:f>
                <c:numCache>
                  <c:formatCode>General</c:formatCode>
                  <c:ptCount val="2"/>
                  <c:pt idx="0">
                    <c:v>11.510450737937077</c:v>
                  </c:pt>
                  <c:pt idx="1">
                    <c:v>15.67866697160968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'SANI CD32'!$J$156:$J$157</c:f>
              <c:strCache>
                <c:ptCount val="2"/>
                <c:pt idx="0">
                  <c:v>H/H</c:v>
                </c:pt>
                <c:pt idx="1">
                  <c:v>R carrier</c:v>
                </c:pt>
              </c:strCache>
            </c:strRef>
          </c:cat>
          <c:val>
            <c:numRef>
              <c:f>'SANI CD32'!$L$156:$L$157</c:f>
              <c:numCache>
                <c:formatCode>0.00</c:formatCode>
                <c:ptCount val="2"/>
                <c:pt idx="0">
                  <c:v>5.9047619047619051</c:v>
                </c:pt>
                <c:pt idx="1">
                  <c:v>11.5813953488372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9176448"/>
        <c:axId val="79177984"/>
      </c:barChart>
      <c:catAx>
        <c:axId val="791764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79177984"/>
        <c:crosses val="autoZero"/>
        <c:auto val="1"/>
        <c:lblAlgn val="ctr"/>
        <c:lblOffset val="100"/>
        <c:noMultiLvlLbl val="0"/>
      </c:catAx>
      <c:valAx>
        <c:axId val="79177984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791764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38589280924535557"/>
          <c:y val="7.4788877801385253E-2"/>
          <c:w val="0.16165973814016371"/>
          <c:h val="0.2187052389977393"/>
        </c:manualLayout>
      </c:layout>
      <c:overlay val="0"/>
      <c:txPr>
        <a:bodyPr/>
        <a:lstStyle/>
        <a:p>
          <a:pPr>
            <a:defRPr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o 2"/>
          <p:cNvGrpSpPr/>
          <p:nvPr/>
        </p:nvGrpSpPr>
        <p:grpSpPr>
          <a:xfrm>
            <a:off x="103508" y="-13069"/>
            <a:ext cx="9174880" cy="4955547"/>
            <a:chOff x="103509" y="-7548"/>
            <a:chExt cx="8860979" cy="6866639"/>
          </a:xfrm>
        </p:grpSpPr>
        <p:graphicFrame>
          <p:nvGraphicFramePr>
            <p:cNvPr id="18" name="Grafico 1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7962467"/>
                </p:ext>
              </p:extLst>
            </p:nvPr>
          </p:nvGraphicFramePr>
          <p:xfrm>
            <a:off x="751037" y="640433"/>
            <a:ext cx="3707804" cy="197557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9" name="Grafico 1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3153476"/>
                </p:ext>
              </p:extLst>
            </p:nvPr>
          </p:nvGraphicFramePr>
          <p:xfrm>
            <a:off x="5074091" y="645287"/>
            <a:ext cx="3798168" cy="194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22" name="Grafico 2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25744267"/>
                </p:ext>
              </p:extLst>
            </p:nvPr>
          </p:nvGraphicFramePr>
          <p:xfrm>
            <a:off x="736525" y="2720438"/>
            <a:ext cx="3722315" cy="20093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23" name="Grafico 2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45786828"/>
                </p:ext>
              </p:extLst>
            </p:nvPr>
          </p:nvGraphicFramePr>
          <p:xfrm>
            <a:off x="5071040" y="2636913"/>
            <a:ext cx="3816424" cy="206278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24" name="Grafico 2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4856001"/>
                </p:ext>
              </p:extLst>
            </p:nvPr>
          </p:nvGraphicFramePr>
          <p:xfrm>
            <a:off x="736526" y="4888904"/>
            <a:ext cx="3763466" cy="19690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25" name="Grafico 2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84717821"/>
                </p:ext>
              </p:extLst>
            </p:nvPr>
          </p:nvGraphicFramePr>
          <p:xfrm>
            <a:off x="5090889" y="4888905"/>
            <a:ext cx="3873599" cy="197018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26" name="CasellaDiTesto 4"/>
            <p:cNvSpPr txBox="1"/>
            <p:nvPr/>
          </p:nvSpPr>
          <p:spPr>
            <a:xfrm>
              <a:off x="1433876" y="142551"/>
              <a:ext cx="1800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4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cγRIIIA</a:t>
              </a:r>
              <a:r>
                <a:rPr lang="en-GB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8V&gt;F</a:t>
              </a:r>
              <a:endPara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ttangolo 26"/>
            <p:cNvSpPr/>
            <p:nvPr/>
          </p:nvSpPr>
          <p:spPr>
            <a:xfrm>
              <a:off x="5763369" y="116632"/>
              <a:ext cx="1534138" cy="523220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4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cγRIIA</a:t>
              </a:r>
              <a:r>
                <a:rPr lang="en-GB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1H&gt;R</a:t>
              </a:r>
              <a:endPara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CasellaDiTesto 30"/>
            <p:cNvSpPr txBox="1"/>
            <p:nvPr/>
          </p:nvSpPr>
          <p:spPr>
            <a:xfrm rot="16200000">
              <a:off x="-317496" y="1228298"/>
              <a:ext cx="2016225" cy="2080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</a:t>
              </a:r>
              <a:r>
                <a:rPr lang="it-IT" sz="8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1</a:t>
              </a:r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r </a:t>
              </a:r>
              <a:r>
                <a:rPr lang="it-IT" sz="8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ecific</a:t>
              </a:r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lease</a:t>
              </a:r>
              <a:endPara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CasellaDiTesto 33"/>
            <p:cNvSpPr txBox="1"/>
            <p:nvPr/>
          </p:nvSpPr>
          <p:spPr>
            <a:xfrm rot="16200000">
              <a:off x="-317014" y="3302428"/>
              <a:ext cx="2016225" cy="2080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</a:t>
              </a:r>
              <a:r>
                <a:rPr lang="it-IT" sz="8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1</a:t>
              </a:r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r </a:t>
              </a:r>
              <a:r>
                <a:rPr lang="it-IT" sz="8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ecific</a:t>
              </a:r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lease</a:t>
              </a:r>
              <a:endPara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CasellaDiTesto 34"/>
            <p:cNvSpPr txBox="1"/>
            <p:nvPr/>
          </p:nvSpPr>
          <p:spPr>
            <a:xfrm rot="16200000">
              <a:off x="-326538" y="5470700"/>
              <a:ext cx="2016225" cy="2080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</a:t>
              </a:r>
              <a:r>
                <a:rPr lang="it-IT" sz="8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1</a:t>
              </a:r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r </a:t>
              </a:r>
              <a:r>
                <a:rPr lang="it-IT" sz="8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ecific</a:t>
              </a:r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lease</a:t>
              </a:r>
              <a:endPara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CasellaDiTesto 35"/>
            <p:cNvSpPr txBox="1"/>
            <p:nvPr/>
          </p:nvSpPr>
          <p:spPr>
            <a:xfrm rot="16200000">
              <a:off x="4026319" y="1257095"/>
              <a:ext cx="2016225" cy="2080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</a:t>
              </a:r>
              <a:r>
                <a:rPr lang="it-IT" sz="8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1</a:t>
              </a:r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r </a:t>
              </a:r>
              <a:r>
                <a:rPr lang="it-IT" sz="8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ecific</a:t>
              </a:r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lease</a:t>
              </a:r>
              <a:endPara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CasellaDiTesto 36"/>
            <p:cNvSpPr txBox="1"/>
            <p:nvPr/>
          </p:nvSpPr>
          <p:spPr>
            <a:xfrm rot="16200000">
              <a:off x="4035750" y="3292903"/>
              <a:ext cx="2016225" cy="2080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</a:t>
              </a:r>
              <a:r>
                <a:rPr lang="it-IT" sz="8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1</a:t>
              </a:r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r </a:t>
              </a:r>
              <a:r>
                <a:rPr lang="it-IT" sz="8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ecific</a:t>
              </a:r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lease</a:t>
              </a:r>
              <a:endPara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CasellaDiTesto 37"/>
            <p:cNvSpPr txBox="1"/>
            <p:nvPr/>
          </p:nvSpPr>
          <p:spPr>
            <a:xfrm rot="16200000">
              <a:off x="4045277" y="5466491"/>
              <a:ext cx="2016225" cy="2080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</a:t>
              </a:r>
              <a:r>
                <a:rPr lang="it-IT" sz="8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1</a:t>
              </a:r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r </a:t>
              </a:r>
              <a:r>
                <a:rPr lang="it-IT" sz="8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ecific</a:t>
              </a:r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lease</a:t>
              </a:r>
              <a:endPara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CasellaDiTesto 40"/>
            <p:cNvSpPr txBox="1"/>
            <p:nvPr/>
          </p:nvSpPr>
          <p:spPr>
            <a:xfrm>
              <a:off x="3009251" y="921956"/>
              <a:ext cx="4042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CasellaDiTesto 41"/>
            <p:cNvSpPr txBox="1"/>
            <p:nvPr/>
          </p:nvSpPr>
          <p:spPr>
            <a:xfrm>
              <a:off x="6064315" y="1190055"/>
              <a:ext cx="4042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CasellaDiTesto 43"/>
            <p:cNvSpPr txBox="1"/>
            <p:nvPr/>
          </p:nvSpPr>
          <p:spPr>
            <a:xfrm>
              <a:off x="7406606" y="851826"/>
              <a:ext cx="4042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CasellaDiTesto 44"/>
            <p:cNvSpPr txBox="1"/>
            <p:nvPr/>
          </p:nvSpPr>
          <p:spPr>
            <a:xfrm>
              <a:off x="3007085" y="2936167"/>
              <a:ext cx="404252" cy="2238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CasellaDiTesto 47"/>
            <p:cNvSpPr txBox="1"/>
            <p:nvPr/>
          </p:nvSpPr>
          <p:spPr>
            <a:xfrm>
              <a:off x="3044870" y="5126995"/>
              <a:ext cx="4042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CasellaDiTesto 49"/>
            <p:cNvSpPr txBox="1"/>
            <p:nvPr/>
          </p:nvSpPr>
          <p:spPr>
            <a:xfrm>
              <a:off x="6066747" y="3168495"/>
              <a:ext cx="4042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CasellaDiTesto 50"/>
            <p:cNvSpPr txBox="1"/>
            <p:nvPr/>
          </p:nvSpPr>
          <p:spPr>
            <a:xfrm>
              <a:off x="7416595" y="2693807"/>
              <a:ext cx="4042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CasellaDiTesto 51"/>
            <p:cNvSpPr txBox="1"/>
            <p:nvPr/>
          </p:nvSpPr>
          <p:spPr>
            <a:xfrm>
              <a:off x="7485240" y="4975422"/>
              <a:ext cx="4042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CasellaDiTesto 52"/>
            <p:cNvSpPr txBox="1"/>
            <p:nvPr/>
          </p:nvSpPr>
          <p:spPr>
            <a:xfrm>
              <a:off x="6167064" y="5442523"/>
              <a:ext cx="4042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CasellaDiTesto 38"/>
            <p:cNvSpPr txBox="1"/>
            <p:nvPr/>
          </p:nvSpPr>
          <p:spPr>
            <a:xfrm>
              <a:off x="103509" y="412078"/>
              <a:ext cx="12961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: SKBR3</a:t>
              </a:r>
              <a:endPara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CasellaDiTesto 39"/>
            <p:cNvSpPr txBox="1"/>
            <p:nvPr/>
          </p:nvSpPr>
          <p:spPr>
            <a:xfrm>
              <a:off x="103509" y="2473420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it-IT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BT474</a:t>
              </a:r>
              <a:endPara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CasellaDiTesto 46"/>
            <p:cNvSpPr txBox="1"/>
            <p:nvPr/>
          </p:nvSpPr>
          <p:spPr>
            <a:xfrm>
              <a:off x="103509" y="4616792"/>
              <a:ext cx="1080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it-IT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MCF-7</a:t>
              </a:r>
              <a:endPara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CasellaDiTesto 53"/>
            <p:cNvSpPr txBox="1"/>
            <p:nvPr/>
          </p:nvSpPr>
          <p:spPr>
            <a:xfrm>
              <a:off x="4363533" y="423730"/>
              <a:ext cx="12961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r>
                <a:rPr lang="it-IT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SKBR3</a:t>
              </a:r>
              <a:endPara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CasellaDiTesto 54"/>
            <p:cNvSpPr txBox="1"/>
            <p:nvPr/>
          </p:nvSpPr>
          <p:spPr>
            <a:xfrm>
              <a:off x="4363533" y="2462301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r>
                <a:rPr lang="it-IT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BT474</a:t>
              </a:r>
              <a:endPara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CasellaDiTesto 55"/>
            <p:cNvSpPr txBox="1"/>
            <p:nvPr/>
          </p:nvSpPr>
          <p:spPr>
            <a:xfrm>
              <a:off x="4363533" y="4605673"/>
              <a:ext cx="1080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it-IT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MCF-7</a:t>
              </a:r>
              <a:endPara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CasellaDiTesto 59"/>
            <p:cNvSpPr txBox="1"/>
            <p:nvPr/>
          </p:nvSpPr>
          <p:spPr>
            <a:xfrm>
              <a:off x="3275856" y="-7548"/>
              <a:ext cx="2383821" cy="3539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700" b="1" dirty="0" smtClean="0">
                  <a:latin typeface="Times New Roman" pitchFamily="18" charset="0"/>
                  <a:cs typeface="Times New Roman" pitchFamily="18" charset="0"/>
                </a:rPr>
                <a:t>HEALTHY DONORS</a:t>
              </a:r>
              <a:endParaRPr lang="it-IT" sz="17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46" name="Rettangolo 45"/>
          <p:cNvSpPr/>
          <p:nvPr/>
        </p:nvSpPr>
        <p:spPr>
          <a:xfrm>
            <a:off x="103509" y="5050621"/>
            <a:ext cx="9004997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al and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stuzumab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mediated cytotoxicity of BC cell lines induced by PBMCs derived from healthy donors according to the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cγRIII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58V&gt;F and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cγRII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31R&gt;H </a:t>
            </a:r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types.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BMCs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healthy donors (n=64) were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zed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their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lytic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tivity in an ADCC assay using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stuzumab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 µg/ml) and SKBR3 (A, D), BT474 (B, E) and MCF-7 (C, F) cell lines at 20:1 effector to target (E:T) cell ratio. PBMCs were incubated with target cells in medium alone (BASAL) or in the presence of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stuzumab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DCC). Results are expressed as % of </a:t>
            </a:r>
            <a:r>
              <a:rPr lang="en-GB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1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 specific release and are the mean of experiments with all the 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nors.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efficient of variation (CV%) was calculated as the standard deviation of cell lysis values among all the PBMC samples divided by the mean and multiplied by 100. CV% at 20:1 E:T ratio for SKBR3: ADCC=106%, BASAL=155%; for BT474: ADCC=103%, BASAL=249%; for MCF-7: ADCC=150%, BASAL=227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.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els 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C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V/V carriers (n=9) and F carriers (n=55) refer to PBMCs from donors carrying the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cγRIIIA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158V/V) wild type genotype and the heterozygous (V/F) together with the mutated (F/F) genotype (158 F carrier), 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.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els 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F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H/H carriers (n=21) and R carriers (n=43) refer to PBMCs from donors carrying the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cγRIIIA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131H/H) wild type genotype and the heterozygous (H/R) together with the mutated (R/R) genotype (131 R carrier), respectively. 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erisks on the bars indicate significant ADCC evaluated using a paired Student’s t-test (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&lt;0.0001 for 158F carrier, 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ranging from 0.0261 to &lt;0.0001 for 131H/H and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&lt;0.0001 for 131R carrier 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CC, antibody-dependent cellular cytotoxicity.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CasellaDiTesto 5"/>
          <p:cNvSpPr txBox="1"/>
          <p:nvPr/>
        </p:nvSpPr>
        <p:spPr>
          <a:xfrm>
            <a:off x="-36512" y="-99392"/>
            <a:ext cx="25202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it-IT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le 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it-IT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it-IT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it-IT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endParaRPr lang="it-IT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31750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391</Words>
  <Application>Microsoft Office PowerPoint</Application>
  <PresentationFormat>Presentazione su schermo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ser</dc:creator>
  <cp:lastModifiedBy>MariaPia Pistillo</cp:lastModifiedBy>
  <cp:revision>45</cp:revision>
  <cp:lastPrinted>2015-10-05T07:29:57Z</cp:lastPrinted>
  <dcterms:created xsi:type="dcterms:W3CDTF">2015-06-23T09:26:26Z</dcterms:created>
  <dcterms:modified xsi:type="dcterms:W3CDTF">2015-10-07T16:52:15Z</dcterms:modified>
</cp:coreProperties>
</file>